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A79472-F424-4BF6-91C5-07FA9800ED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AEC0CA-73DC-4529-97EA-AACB4FBC28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080DFF-14C0-4D29-81C3-4DDF37335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5F7300-9DE0-4294-B437-A7C9503E5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5EF7B5-94BF-4989-9911-33A14EA20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205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23D7AD-2355-4CD5-9F18-FE72ED8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33395A-3B88-4F54-B040-CC3BAE105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61D49-DFF8-4D18-B0DD-0F37AE633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06B0E-C211-4FD9-991D-9FB83019D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5CDD79-D055-4B02-A8D7-93198FB18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870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CF7AFF-3275-44F8-86D7-3EBC3FEFB9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AECC2F-F50F-47D5-81A1-F630146BB1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D7FD9-353F-4F5B-982F-64C7D48DD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E460D3-D29E-4A89-AC66-CBE9894D1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7AC74-9147-49C9-984F-7F4869734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784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AB026-4CDB-4F19-B5A7-A0F1F7E7D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A937DC-3530-4441-B9D2-F2E48B18E1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62BA1-127A-4E5B-A944-5E2BF0D21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242E44-3A72-47EF-B28F-F0869CCAD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41794A-6A4D-4E34-AB5D-A9DFE4FD0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347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FD7D27-2275-40B5-B045-68AE4E9EE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0FA337-BFCF-49C0-A1C6-933F4E615C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BC98F5-13E7-4E8A-944E-92E161DAC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051A6-77C9-490C-A2E6-144D20B58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A9D44D-7FAF-413C-AA4C-ABBAA3A27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520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8C871-9777-41A2-A444-F441BD7A32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FB8D5E-0564-48E4-9A81-F21EA32A7A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37B797-DB98-49CC-9DE5-9C2F042122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4B3318-D5D6-4C6D-820A-ABF928679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714950-D0B0-4E68-9C3F-6291D98AD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6C2289-82A0-4E2D-8A2C-8DEEB53EF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240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FA8EFE-2C11-4CEA-9480-90D0BD8CF6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CC65E5-AF2E-4506-BBB0-37D3A5D0F0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9D4D40-9844-438D-9699-C533B22D33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A59171-3965-47D4-98D5-87A20F9918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21CF68-FC7A-4CBC-9159-F981BB4F99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D45062-2FAA-410B-84FF-A37A242BC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BD326D-BA48-441B-A4C3-8AC63E8CB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352409-1970-471A-A06B-97F152460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653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507DD-E877-4154-A39B-31EEA1CB6D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46AFC08-DDF1-44E8-A0ED-AF660682E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AD59FA-605E-4CEE-9440-55E0524AB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54E06B-2CB3-4E3C-A53D-2F3E1B3CC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014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8A45FE-683B-47F1-BB6E-936E27FC2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C4E962-1793-4156-82DD-25D810EFF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F3A62A-B8BF-4259-8DBE-65D63CF4D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24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2F1C3-D62A-4565-9BB9-D5D00807E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FDCEEE-CFFA-478C-BB0B-2790B23E03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716115-74AE-4576-8063-DF9336D32B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A09871-AE1F-4AE2-94EF-87DF3C171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7784BC-FB7C-4FAA-9538-E30B0219D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7E8714-70F3-4FA8-99B7-3B3FAFF98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098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9509D-4AAB-488C-B2E6-E97B38671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C1CCFC-74E3-440B-AA25-99C624D97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DD86D-2D07-4D4C-9F1E-0C0D5B9EA9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FD7D6C-3BC3-4F2B-9F2C-2B2C3FCF9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A0610D-A2A0-4ACC-9652-2E17184F5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0960B4-7E70-44C9-9D70-042501B04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919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83A220-C432-40B2-9A13-426584978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AF44ED-2BD7-435D-A9F7-077EF5EBAB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F51203-3B18-4D5D-8180-889E1DC8F6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845BB-2371-4488-B949-EDD0A75CC45B}" type="datetimeFigureOut">
              <a:rPr lang="en-US" smtClean="0"/>
              <a:t>11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AC7CAC-FF7F-40F3-A492-F92676B03B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D09E9-DA81-4E1D-B4F7-EC48973354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1BC86-2B7D-420A-BB12-66719EC17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83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1353727-8E63-475A-BBEF-B048A0E10930}"/>
              </a:ext>
            </a:extLst>
          </p:cNvPr>
          <p:cNvGrpSpPr/>
          <p:nvPr/>
        </p:nvGrpSpPr>
        <p:grpSpPr>
          <a:xfrm>
            <a:off x="1758647" y="630859"/>
            <a:ext cx="8247856" cy="5675214"/>
            <a:chOff x="1287307" y="713158"/>
            <a:chExt cx="8247856" cy="5675214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252E006-7D2B-4951-AE60-2019352E6A82}"/>
                </a:ext>
              </a:extLst>
            </p:cNvPr>
            <p:cNvGrpSpPr/>
            <p:nvPr/>
          </p:nvGrpSpPr>
          <p:grpSpPr>
            <a:xfrm>
              <a:off x="1287307" y="713158"/>
              <a:ext cx="8247856" cy="5675214"/>
              <a:chOff x="514307" y="543475"/>
              <a:chExt cx="8247856" cy="5675214"/>
            </a:xfrm>
          </p:grpSpPr>
          <p:sp>
            <p:nvSpPr>
              <p:cNvPr id="5" name="Arrow: Pentagon 4">
                <a:extLst>
                  <a:ext uri="{FF2B5EF4-FFF2-40B4-BE49-F238E27FC236}">
                    <a16:creationId xmlns:a16="http://schemas.microsoft.com/office/drawing/2014/main" id="{D7E8C9EF-F1C0-4D52-BA0C-6A1FA331C0CD}"/>
                  </a:ext>
                </a:extLst>
              </p:cNvPr>
              <p:cNvSpPr/>
              <p:nvPr/>
            </p:nvSpPr>
            <p:spPr>
              <a:xfrm>
                <a:off x="1962812" y="2176084"/>
                <a:ext cx="1302696" cy="461172"/>
              </a:xfrm>
              <a:prstGeom prst="homePlat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mithion exposure </a:t>
                </a:r>
              </a:p>
            </p:txBody>
          </p: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B9387F59-7FE4-4256-822C-25D5925ADA37}"/>
                  </a:ext>
                </a:extLst>
              </p:cNvPr>
              <p:cNvGrpSpPr/>
              <p:nvPr/>
            </p:nvGrpSpPr>
            <p:grpSpPr>
              <a:xfrm>
                <a:off x="6933229" y="2220196"/>
                <a:ext cx="1828934" cy="636914"/>
                <a:chOff x="5915454" y="3178858"/>
                <a:chExt cx="1885798" cy="700803"/>
              </a:xfrm>
            </p:grpSpPr>
            <p:sp>
              <p:nvSpPr>
                <p:cNvPr id="62" name="Oval 61">
                  <a:extLst>
                    <a:ext uri="{FF2B5EF4-FFF2-40B4-BE49-F238E27FC236}">
                      <a16:creationId xmlns:a16="http://schemas.microsoft.com/office/drawing/2014/main" id="{9B72C852-39DF-48AC-AA5D-8FBA6927612E}"/>
                    </a:ext>
                  </a:extLst>
                </p:cNvPr>
                <p:cNvSpPr/>
                <p:nvPr/>
              </p:nvSpPr>
              <p:spPr>
                <a:xfrm>
                  <a:off x="5915454" y="3353959"/>
                  <a:ext cx="888903" cy="275968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GR</a:t>
                  </a:r>
                </a:p>
              </p:txBody>
            </p:sp>
            <p:sp>
              <p:nvSpPr>
                <p:cNvPr id="63" name="Oval 62">
                  <a:extLst>
                    <a:ext uri="{FF2B5EF4-FFF2-40B4-BE49-F238E27FC236}">
                      <a16:creationId xmlns:a16="http://schemas.microsoft.com/office/drawing/2014/main" id="{CC6AE3DC-9F6A-4C72-9FD7-EE40DEC20394}"/>
                    </a:ext>
                  </a:extLst>
                </p:cNvPr>
                <p:cNvSpPr/>
                <p:nvPr/>
              </p:nvSpPr>
              <p:spPr>
                <a:xfrm>
                  <a:off x="6183544" y="3637078"/>
                  <a:ext cx="831991" cy="242583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G</a:t>
                  </a:r>
                </a:p>
              </p:txBody>
            </p:sp>
            <p:sp>
              <p:nvSpPr>
                <p:cNvPr id="64" name="Oval 63">
                  <a:extLst>
                    <a:ext uri="{FF2B5EF4-FFF2-40B4-BE49-F238E27FC236}">
                      <a16:creationId xmlns:a16="http://schemas.microsoft.com/office/drawing/2014/main" id="{DED4C703-45BC-4577-8C99-94E9E065C8F8}"/>
                    </a:ext>
                  </a:extLst>
                </p:cNvPr>
                <p:cNvSpPr/>
                <p:nvPr/>
              </p:nvSpPr>
              <p:spPr>
                <a:xfrm>
                  <a:off x="6941668" y="3435385"/>
                  <a:ext cx="859584" cy="29634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CR</a:t>
                  </a:r>
                </a:p>
              </p:txBody>
            </p:sp>
            <p:sp>
              <p:nvSpPr>
                <p:cNvPr id="65" name="Plus Sign 64">
                  <a:extLst>
                    <a:ext uri="{FF2B5EF4-FFF2-40B4-BE49-F238E27FC236}">
                      <a16:creationId xmlns:a16="http://schemas.microsoft.com/office/drawing/2014/main" id="{BA143ED1-4159-4890-B5F2-9BA5FAEF37C8}"/>
                    </a:ext>
                  </a:extLst>
                </p:cNvPr>
                <p:cNvSpPr/>
                <p:nvPr/>
              </p:nvSpPr>
              <p:spPr>
                <a:xfrm>
                  <a:off x="7399662" y="3301367"/>
                  <a:ext cx="273535" cy="255266"/>
                </a:xfrm>
                <a:prstGeom prst="mathPlus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" name="Minus Sign 65">
                  <a:extLst>
                    <a:ext uri="{FF2B5EF4-FFF2-40B4-BE49-F238E27FC236}">
                      <a16:creationId xmlns:a16="http://schemas.microsoft.com/office/drawing/2014/main" id="{5A49DF9F-1B4D-4CD1-AD1A-7970E0EB1A41}"/>
                    </a:ext>
                  </a:extLst>
                </p:cNvPr>
                <p:cNvSpPr/>
                <p:nvPr/>
              </p:nvSpPr>
              <p:spPr>
                <a:xfrm>
                  <a:off x="6507352" y="3178858"/>
                  <a:ext cx="306261" cy="286936"/>
                </a:xfrm>
                <a:prstGeom prst="mathMinus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7" name="Minus Sign 66">
                  <a:extLst>
                    <a:ext uri="{FF2B5EF4-FFF2-40B4-BE49-F238E27FC236}">
                      <a16:creationId xmlns:a16="http://schemas.microsoft.com/office/drawing/2014/main" id="{DEF056B6-FD82-43D4-BD7F-589F924F137C}"/>
                    </a:ext>
                  </a:extLst>
                </p:cNvPr>
                <p:cNvSpPr/>
                <p:nvPr/>
              </p:nvSpPr>
              <p:spPr>
                <a:xfrm>
                  <a:off x="6701171" y="3505912"/>
                  <a:ext cx="325179" cy="293488"/>
                </a:xfrm>
                <a:prstGeom prst="mathMinus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E009027E-6485-47D2-9F74-774971027F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14307" y="1904118"/>
                <a:ext cx="1432284" cy="733138"/>
              </a:xfrm>
              <a:prstGeom prst="rect">
                <a:avLst/>
              </a:prstGeom>
              <a:noFill/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AA6BDB4C-1B55-4F2E-A8C5-09A7B2B6B5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314220" y="1584990"/>
                <a:ext cx="1946374" cy="1182188"/>
              </a:xfrm>
              <a:prstGeom prst="rect">
                <a:avLst/>
              </a:prstGeom>
              <a:scene3d>
                <a:camera prst="orthographicFront"/>
                <a:lightRig rig="threePt" dir="t"/>
              </a:scene3d>
              <a:sp3d>
                <a:bevelT prst="angle"/>
              </a:sp3d>
            </p:spPr>
          </p:pic>
          <p:sp>
            <p:nvSpPr>
              <p:cNvPr id="9" name="Arrow: Pentagon 8">
                <a:extLst>
                  <a:ext uri="{FF2B5EF4-FFF2-40B4-BE49-F238E27FC236}">
                    <a16:creationId xmlns:a16="http://schemas.microsoft.com/office/drawing/2014/main" id="{926D07BF-9465-4D9F-B07D-3761AA80FBF3}"/>
                  </a:ext>
                </a:extLst>
              </p:cNvPr>
              <p:cNvSpPr/>
              <p:nvPr/>
            </p:nvSpPr>
            <p:spPr>
              <a:xfrm rot="20984659">
                <a:off x="5306444" y="1933768"/>
                <a:ext cx="444344" cy="242316"/>
              </a:xfrm>
              <a:prstGeom prst="homePlate">
                <a:avLst>
                  <a:gd name="adj" fmla="val 83068"/>
                </a:avLst>
              </a:prstGeom>
              <a:solidFill>
                <a:schemeClr val="accent6">
                  <a:lumMod val="40000"/>
                  <a:lumOff val="6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Arrow: Pentagon 9">
                <a:extLst>
                  <a:ext uri="{FF2B5EF4-FFF2-40B4-BE49-F238E27FC236}">
                    <a16:creationId xmlns:a16="http://schemas.microsoft.com/office/drawing/2014/main" id="{4FCF6889-95DE-4860-996D-851527EB91C4}"/>
                  </a:ext>
                </a:extLst>
              </p:cNvPr>
              <p:cNvSpPr/>
              <p:nvPr/>
            </p:nvSpPr>
            <p:spPr>
              <a:xfrm rot="19844112">
                <a:off x="4915276" y="1220619"/>
                <a:ext cx="458451" cy="289432"/>
              </a:xfrm>
              <a:prstGeom prst="homePlate">
                <a:avLst>
                  <a:gd name="adj" fmla="val 83068"/>
                </a:avLst>
              </a:prstGeom>
              <a:solidFill>
                <a:schemeClr val="accent5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" name="Arrow: Pentagon 10">
                <a:extLst>
                  <a:ext uri="{FF2B5EF4-FFF2-40B4-BE49-F238E27FC236}">
                    <a16:creationId xmlns:a16="http://schemas.microsoft.com/office/drawing/2014/main" id="{5A65C70C-C6AD-4003-AACC-5514B19A0D62}"/>
                  </a:ext>
                </a:extLst>
              </p:cNvPr>
              <p:cNvSpPr/>
              <p:nvPr/>
            </p:nvSpPr>
            <p:spPr>
              <a:xfrm>
                <a:off x="5259694" y="2467906"/>
                <a:ext cx="430536" cy="224124"/>
              </a:xfrm>
              <a:prstGeom prst="homePlate">
                <a:avLst>
                  <a:gd name="adj" fmla="val 83068"/>
                </a:avLst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6EBA7FAF-18A9-4E6D-A8CD-EB9C0FEC4308}"/>
                  </a:ext>
                </a:extLst>
              </p:cNvPr>
              <p:cNvGrpSpPr/>
              <p:nvPr/>
            </p:nvGrpSpPr>
            <p:grpSpPr>
              <a:xfrm>
                <a:off x="7141004" y="1057578"/>
                <a:ext cx="1328998" cy="1215444"/>
                <a:chOff x="7177582" y="4538985"/>
                <a:chExt cx="1328998" cy="1215444"/>
              </a:xfrm>
            </p:grpSpPr>
            <p:sp>
              <p:nvSpPr>
                <p:cNvPr id="58" name="Rectangle 57">
                  <a:extLst>
                    <a:ext uri="{FF2B5EF4-FFF2-40B4-BE49-F238E27FC236}">
                      <a16:creationId xmlns:a16="http://schemas.microsoft.com/office/drawing/2014/main" id="{DC41E1FA-031A-4F2A-9522-23FA8E43F26E}"/>
                    </a:ext>
                  </a:extLst>
                </p:cNvPr>
                <p:cNvSpPr/>
                <p:nvPr/>
              </p:nvSpPr>
              <p:spPr>
                <a:xfrm>
                  <a:off x="7177582" y="4538985"/>
                  <a:ext cx="732548" cy="121544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2">
                      <a:lumMod val="9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h</a:t>
                  </a:r>
                </a:p>
                <a:p>
                  <a:pPr algn="ctr"/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gf-1</a:t>
                  </a:r>
                </a:p>
                <a:p>
                  <a:pPr algn="ctr"/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gf-2, </a:t>
                  </a:r>
                </a:p>
                <a:p>
                  <a:pPr algn="ctr"/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FN-</a:t>
                  </a:r>
                  <a:r>
                    <a:rPr lang="el-GR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γ </a:t>
                  </a:r>
                  <a:endParaRPr lang="en-US" sz="14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l-GR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NF-</a:t>
                  </a:r>
                  <a:r>
                    <a:rPr lang="el-GR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α</a:t>
                  </a:r>
                  <a:endParaRPr lang="en-US" sz="14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L-1-</a:t>
                  </a:r>
                  <a:r>
                    <a:rPr lang="el-GR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 </a:t>
                  </a:r>
                </a:p>
              </p:txBody>
            </p:sp>
            <p:sp>
              <p:nvSpPr>
                <p:cNvPr id="59" name="Rectangle 58">
                  <a:extLst>
                    <a:ext uri="{FF2B5EF4-FFF2-40B4-BE49-F238E27FC236}">
                      <a16:creationId xmlns:a16="http://schemas.microsoft.com/office/drawing/2014/main" id="{590D5A62-1C9F-4092-A7CB-419FA6924D62}"/>
                    </a:ext>
                  </a:extLst>
                </p:cNvPr>
                <p:cNvSpPr/>
                <p:nvPr/>
              </p:nvSpPr>
              <p:spPr>
                <a:xfrm>
                  <a:off x="7930540" y="4899403"/>
                  <a:ext cx="576040" cy="497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OD CAT</a:t>
                  </a:r>
                </a:p>
              </p:txBody>
            </p:sp>
            <p:sp>
              <p:nvSpPr>
                <p:cNvPr id="60" name="Arrow: Down 59">
                  <a:extLst>
                    <a:ext uri="{FF2B5EF4-FFF2-40B4-BE49-F238E27FC236}">
                      <a16:creationId xmlns:a16="http://schemas.microsoft.com/office/drawing/2014/main" id="{55FD991A-8878-4293-9EBD-FB5936F98950}"/>
                    </a:ext>
                  </a:extLst>
                </p:cNvPr>
                <p:cNvSpPr/>
                <p:nvPr/>
              </p:nvSpPr>
              <p:spPr>
                <a:xfrm>
                  <a:off x="7833480" y="4545464"/>
                  <a:ext cx="75541" cy="1199471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1" name="Arrow: Down 60">
                  <a:extLst>
                    <a:ext uri="{FF2B5EF4-FFF2-40B4-BE49-F238E27FC236}">
                      <a16:creationId xmlns:a16="http://schemas.microsoft.com/office/drawing/2014/main" id="{FF8573ED-58F3-4564-9BD9-4FC912BF2867}"/>
                    </a:ext>
                  </a:extLst>
                </p:cNvPr>
                <p:cNvSpPr/>
                <p:nvPr/>
              </p:nvSpPr>
              <p:spPr>
                <a:xfrm flipV="1">
                  <a:off x="8297257" y="4882753"/>
                  <a:ext cx="112002" cy="497448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1CE230EA-34E4-47F2-B2BC-EF76370069E8}"/>
                  </a:ext>
                </a:extLst>
              </p:cNvPr>
              <p:cNvGrpSpPr/>
              <p:nvPr/>
            </p:nvGrpSpPr>
            <p:grpSpPr>
              <a:xfrm>
                <a:off x="5338067" y="543475"/>
                <a:ext cx="1449342" cy="1051953"/>
                <a:chOff x="5338067" y="543475"/>
                <a:chExt cx="1449342" cy="1051953"/>
              </a:xfrm>
            </p:grpSpPr>
            <p:grpSp>
              <p:nvGrpSpPr>
                <p:cNvPr id="54" name="Group 53">
                  <a:extLst>
                    <a:ext uri="{FF2B5EF4-FFF2-40B4-BE49-F238E27FC236}">
                      <a16:creationId xmlns:a16="http://schemas.microsoft.com/office/drawing/2014/main" id="{38B1EF29-2554-4C8F-AF56-B4CAE44F17D9}"/>
                    </a:ext>
                  </a:extLst>
                </p:cNvPr>
                <p:cNvGrpSpPr/>
                <p:nvPr/>
              </p:nvGrpSpPr>
              <p:grpSpPr>
                <a:xfrm>
                  <a:off x="5338067" y="609054"/>
                  <a:ext cx="1449342" cy="986374"/>
                  <a:chOff x="11000852" y="2580313"/>
                  <a:chExt cx="1449342" cy="986374"/>
                </a:xfrm>
              </p:grpSpPr>
              <p:pic>
                <p:nvPicPr>
                  <p:cNvPr id="56" name="Picture 55">
                    <a:extLst>
                      <a:ext uri="{FF2B5EF4-FFF2-40B4-BE49-F238E27FC236}">
                        <a16:creationId xmlns:a16="http://schemas.microsoft.com/office/drawing/2014/main" id="{A10E1258-F69B-4C6D-9260-3A9520DF7E5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rot="16200000">
                    <a:off x="11436230" y="2523431"/>
                    <a:ext cx="641344" cy="755107"/>
                  </a:xfrm>
                  <a:prstGeom prst="rect">
                    <a:avLst/>
                  </a:prstGeom>
                </p:spPr>
              </p:pic>
              <p:sp>
                <p:nvSpPr>
                  <p:cNvPr id="57" name="Rectangle: Rounded Corners 56">
                    <a:extLst>
                      <a:ext uri="{FF2B5EF4-FFF2-40B4-BE49-F238E27FC236}">
                        <a16:creationId xmlns:a16="http://schemas.microsoft.com/office/drawing/2014/main" id="{46CEA80C-3C63-40F8-94AC-35FFB7A76FE0}"/>
                      </a:ext>
                    </a:extLst>
                  </p:cNvPr>
                  <p:cNvSpPr/>
                  <p:nvPr/>
                </p:nvSpPr>
                <p:spPr>
                  <a:xfrm>
                    <a:off x="11000852" y="3182475"/>
                    <a:ext cx="1449342" cy="384212"/>
                  </a:xfrm>
                  <a:prstGeom prst="roundRect">
                    <a:avLst/>
                  </a:prstGeom>
                  <a:solidFill>
                    <a:schemeClr val="bg1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sto-pathological alterations</a:t>
                    </a:r>
                  </a:p>
                </p:txBody>
              </p:sp>
            </p:grpSp>
            <p:sp>
              <p:nvSpPr>
                <p:cNvPr id="55" name="Minus Sign 54">
                  <a:extLst>
                    <a:ext uri="{FF2B5EF4-FFF2-40B4-BE49-F238E27FC236}">
                      <a16:creationId xmlns:a16="http://schemas.microsoft.com/office/drawing/2014/main" id="{B541E502-5471-4496-9480-8238E8E66EC9}"/>
                    </a:ext>
                  </a:extLst>
                </p:cNvPr>
                <p:cNvSpPr/>
                <p:nvPr/>
              </p:nvSpPr>
              <p:spPr>
                <a:xfrm>
                  <a:off x="6283170" y="543475"/>
                  <a:ext cx="346370" cy="141773"/>
                </a:xfrm>
                <a:prstGeom prst="mathMinus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rgbClr val="FF0000"/>
                    </a:solidFill>
                  </a:endParaRPr>
                </a:p>
              </p:txBody>
            </p:sp>
          </p:grpSp>
          <p:sp>
            <p:nvSpPr>
              <p:cNvPr id="14" name="Rectangle: Rounded Corners 13">
                <a:extLst>
                  <a:ext uri="{FF2B5EF4-FFF2-40B4-BE49-F238E27FC236}">
                    <a16:creationId xmlns:a16="http://schemas.microsoft.com/office/drawing/2014/main" id="{0350005F-E9ED-4EB0-B5EE-63C2BB5E603E}"/>
                  </a:ext>
                </a:extLst>
              </p:cNvPr>
              <p:cNvSpPr/>
              <p:nvPr/>
            </p:nvSpPr>
            <p:spPr>
              <a:xfrm>
                <a:off x="3065671" y="1101519"/>
                <a:ext cx="1538803" cy="420449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matobiochemical parameters</a:t>
                </a: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FBC3BC34-44C3-4905-95DA-95D3651B8BF7}"/>
                  </a:ext>
                </a:extLst>
              </p:cNvPr>
              <p:cNvSpPr/>
              <p:nvPr/>
            </p:nvSpPr>
            <p:spPr>
              <a:xfrm>
                <a:off x="3030302" y="662178"/>
                <a:ext cx="521027" cy="35977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u </a:t>
                </a:r>
                <a:r>
                  <a:rPr lang="en-US" sz="1100" dirty="0">
                    <a:solidFill>
                      <a:schemeClr val="accent3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↑</a:t>
                </a:r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b ↓</a:t>
                </a: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DF1C4F67-A15B-4087-802E-57A60E1C7A1B}"/>
                  </a:ext>
                </a:extLst>
              </p:cNvPr>
              <p:cNvGrpSpPr/>
              <p:nvPr/>
            </p:nvGrpSpPr>
            <p:grpSpPr>
              <a:xfrm>
                <a:off x="3802220" y="652027"/>
                <a:ext cx="686274" cy="376282"/>
                <a:chOff x="4145406" y="2820511"/>
                <a:chExt cx="686274" cy="376282"/>
              </a:xfrm>
            </p:grpSpPr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4C64F5DB-BE24-4C70-95A4-27BDFE6E10D9}"/>
                    </a:ext>
                  </a:extLst>
                </p:cNvPr>
                <p:cNvSpPr/>
                <p:nvPr/>
              </p:nvSpPr>
              <p:spPr>
                <a:xfrm>
                  <a:off x="4145406" y="2837021"/>
                  <a:ext cx="521027" cy="3597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CA</a:t>
                  </a:r>
                </a:p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NA</a:t>
                  </a:r>
                </a:p>
              </p:txBody>
            </p:sp>
            <p:sp>
              <p:nvSpPr>
                <p:cNvPr id="53" name="Arrow: Down 52">
                  <a:extLst>
                    <a:ext uri="{FF2B5EF4-FFF2-40B4-BE49-F238E27FC236}">
                      <a16:creationId xmlns:a16="http://schemas.microsoft.com/office/drawing/2014/main" id="{C9BDA956-7957-47CC-BB55-0671BAD13004}"/>
                    </a:ext>
                  </a:extLst>
                </p:cNvPr>
                <p:cNvSpPr/>
                <p:nvPr/>
              </p:nvSpPr>
              <p:spPr>
                <a:xfrm flipV="1">
                  <a:off x="4722995" y="2820511"/>
                  <a:ext cx="108685" cy="359772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7" name="Callout: Down Arrow 16">
                <a:extLst>
                  <a:ext uri="{FF2B5EF4-FFF2-40B4-BE49-F238E27FC236}">
                    <a16:creationId xmlns:a16="http://schemas.microsoft.com/office/drawing/2014/main" id="{0551632F-8870-4FA6-A81D-53F7E554177F}"/>
                  </a:ext>
                </a:extLst>
              </p:cNvPr>
              <p:cNvSpPr/>
              <p:nvPr/>
            </p:nvSpPr>
            <p:spPr>
              <a:xfrm>
                <a:off x="1127047" y="2926316"/>
                <a:ext cx="7453933" cy="938163"/>
              </a:xfrm>
              <a:prstGeom prst="downArrowCallou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effectLst>
                <a:glow rad="63500">
                  <a:schemeClr val="accent3">
                    <a:satMod val="175000"/>
                    <a:alpha val="40000"/>
                  </a:schemeClr>
                </a:glo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iotic incorporation significantly counteracted biomarkers by sumithion exposure in Nile tilapia</a:t>
                </a:r>
              </a:p>
            </p:txBody>
          </p:sp>
          <p:sp>
            <p:nvSpPr>
              <p:cNvPr id="18" name="Rectangle: Rounded Corners 17">
                <a:extLst>
                  <a:ext uri="{FF2B5EF4-FFF2-40B4-BE49-F238E27FC236}">
                    <a16:creationId xmlns:a16="http://schemas.microsoft.com/office/drawing/2014/main" id="{8B347C8E-895C-4A3B-96B6-CE01709C8886}"/>
                  </a:ext>
                </a:extLst>
              </p:cNvPr>
              <p:cNvSpPr/>
              <p:nvPr/>
            </p:nvSpPr>
            <p:spPr>
              <a:xfrm>
                <a:off x="5716563" y="2351016"/>
                <a:ext cx="1120124" cy="395860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owth parameters</a:t>
                </a:r>
              </a:p>
            </p:txBody>
          </p:sp>
          <p:sp>
            <p:nvSpPr>
              <p:cNvPr id="19" name="Plus Sign 18">
                <a:extLst>
                  <a:ext uri="{FF2B5EF4-FFF2-40B4-BE49-F238E27FC236}">
                    <a16:creationId xmlns:a16="http://schemas.microsoft.com/office/drawing/2014/main" id="{E78B143A-505C-4163-9E42-FE3494EC3F5A}"/>
                  </a:ext>
                </a:extLst>
              </p:cNvPr>
              <p:cNvSpPr/>
              <p:nvPr/>
            </p:nvSpPr>
            <p:spPr>
              <a:xfrm>
                <a:off x="6432579" y="3765834"/>
                <a:ext cx="243137" cy="225171"/>
              </a:xfrm>
              <a:prstGeom prst="mathPlus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620C9D78-B24F-47C7-A55D-96507F069059}"/>
                  </a:ext>
                </a:extLst>
              </p:cNvPr>
              <p:cNvGrpSpPr/>
              <p:nvPr/>
            </p:nvGrpSpPr>
            <p:grpSpPr>
              <a:xfrm>
                <a:off x="861554" y="3859983"/>
                <a:ext cx="7719426" cy="2358706"/>
                <a:chOff x="528698" y="3564786"/>
                <a:chExt cx="7719426" cy="2358706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F8A3DCCF-E6F2-4A51-9BC1-D5BF5841839E}"/>
                    </a:ext>
                  </a:extLst>
                </p:cNvPr>
                <p:cNvGrpSpPr/>
                <p:nvPr/>
              </p:nvGrpSpPr>
              <p:grpSpPr>
                <a:xfrm>
                  <a:off x="528698" y="4088752"/>
                  <a:ext cx="1265460" cy="1625206"/>
                  <a:chOff x="0" y="0"/>
                  <a:chExt cx="675005" cy="1097405"/>
                </a:xfrm>
              </p:grpSpPr>
              <p:pic>
                <p:nvPicPr>
                  <p:cNvPr id="49" name="Picture 48">
                    <a:extLst>
                      <a:ext uri="{FF2B5EF4-FFF2-40B4-BE49-F238E27FC236}">
                        <a16:creationId xmlns:a16="http://schemas.microsoft.com/office/drawing/2014/main" id="{3EB925EA-484B-43D4-B180-D36E1AFD552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652" y="639269"/>
                    <a:ext cx="440449" cy="458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/>
                </p:spPr>
              </p:pic>
              <p:pic>
                <p:nvPicPr>
                  <p:cNvPr id="50" name="Picture 49">
                    <a:extLst>
                      <a:ext uri="{FF2B5EF4-FFF2-40B4-BE49-F238E27FC236}">
                        <a16:creationId xmlns:a16="http://schemas.microsoft.com/office/drawing/2014/main" id="{45FCBB1D-2F0C-480C-92F1-DB763329B30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0" y="0"/>
                    <a:ext cx="675005" cy="427990"/>
                  </a:xfrm>
                  <a:prstGeom prst="rect">
                    <a:avLst/>
                  </a:prstGeom>
                  <a:noFill/>
                </p:spPr>
              </p:pic>
              <p:sp>
                <p:nvSpPr>
                  <p:cNvPr id="51" name="Plus Sign 50">
                    <a:extLst>
                      <a:ext uri="{FF2B5EF4-FFF2-40B4-BE49-F238E27FC236}">
                        <a16:creationId xmlns:a16="http://schemas.microsoft.com/office/drawing/2014/main" id="{9D03D4AC-4117-4E0A-A974-6011C0C275E0}"/>
                      </a:ext>
                    </a:extLst>
                  </p:cNvPr>
                  <p:cNvSpPr/>
                  <p:nvPr/>
                </p:nvSpPr>
                <p:spPr>
                  <a:xfrm>
                    <a:off x="217409" y="447608"/>
                    <a:ext cx="198226" cy="217410"/>
                  </a:xfrm>
                  <a:prstGeom prst="mathPlus">
                    <a:avLst/>
                  </a:prstGeom>
                  <a:solidFill>
                    <a:srgbClr val="FF00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</p:grpSp>
            <p:sp>
              <p:nvSpPr>
                <p:cNvPr id="22" name="Arrow: Pentagon 21">
                  <a:extLst>
                    <a:ext uri="{FF2B5EF4-FFF2-40B4-BE49-F238E27FC236}">
                      <a16:creationId xmlns:a16="http://schemas.microsoft.com/office/drawing/2014/main" id="{74AFA193-B8C7-4380-AE81-FF00D9362E5F}"/>
                    </a:ext>
                  </a:extLst>
                </p:cNvPr>
                <p:cNvSpPr/>
                <p:nvPr/>
              </p:nvSpPr>
              <p:spPr>
                <a:xfrm>
                  <a:off x="1721241" y="4671693"/>
                  <a:ext cx="1340401" cy="633833"/>
                </a:xfrm>
                <a:prstGeom prst="homePlate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4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mithion + Probiotics exposure </a:t>
                  </a:r>
                </a:p>
              </p:txBody>
            </p:sp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6D5891EE-EA59-483F-85CA-596771F5DB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040338" y="4420002"/>
                  <a:ext cx="1946374" cy="1182188"/>
                </a:xfrm>
                <a:prstGeom prst="rect">
                  <a:avLst/>
                </a:prstGeom>
                <a:scene3d>
                  <a:camera prst="orthographicFront"/>
                  <a:lightRig rig="threePt" dir="t"/>
                </a:scene3d>
                <a:sp3d>
                  <a:bevelT prst="angle"/>
                </a:sp3d>
              </p:spPr>
            </p:pic>
            <p:sp>
              <p:nvSpPr>
                <p:cNvPr id="24" name="Arrow: Pentagon 23">
                  <a:extLst>
                    <a:ext uri="{FF2B5EF4-FFF2-40B4-BE49-F238E27FC236}">
                      <a16:creationId xmlns:a16="http://schemas.microsoft.com/office/drawing/2014/main" id="{E162253F-174A-4BCC-A02E-A18A65977132}"/>
                    </a:ext>
                  </a:extLst>
                </p:cNvPr>
                <p:cNvSpPr/>
                <p:nvPr/>
              </p:nvSpPr>
              <p:spPr>
                <a:xfrm>
                  <a:off x="5027625" y="5262657"/>
                  <a:ext cx="430536" cy="224124"/>
                </a:xfrm>
                <a:prstGeom prst="homePlate">
                  <a:avLst>
                    <a:gd name="adj" fmla="val 83068"/>
                  </a:avLst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Rectangle: Rounded Corners 24">
                  <a:extLst>
                    <a:ext uri="{FF2B5EF4-FFF2-40B4-BE49-F238E27FC236}">
                      <a16:creationId xmlns:a16="http://schemas.microsoft.com/office/drawing/2014/main" id="{CA23977C-9893-42D7-90DB-74AE94085D16}"/>
                    </a:ext>
                  </a:extLst>
                </p:cNvPr>
                <p:cNvSpPr/>
                <p:nvPr/>
              </p:nvSpPr>
              <p:spPr>
                <a:xfrm>
                  <a:off x="5508099" y="5309894"/>
                  <a:ext cx="1120124" cy="395860"/>
                </a:xfrm>
                <a:prstGeom prst="round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4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rowth parameters</a:t>
                  </a:r>
                </a:p>
              </p:txBody>
            </p:sp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6252DA76-3DB8-44B1-BC7C-6DC6BA30890A}"/>
                    </a:ext>
                  </a:extLst>
                </p:cNvPr>
                <p:cNvGrpSpPr/>
                <p:nvPr/>
              </p:nvGrpSpPr>
              <p:grpSpPr>
                <a:xfrm>
                  <a:off x="6600373" y="5354455"/>
                  <a:ext cx="1647751" cy="569037"/>
                  <a:chOff x="6591846" y="5318777"/>
                  <a:chExt cx="1797866" cy="586281"/>
                </a:xfrm>
              </p:grpSpPr>
              <p:grpSp>
                <p:nvGrpSpPr>
                  <p:cNvPr id="42" name="Group 41">
                    <a:extLst>
                      <a:ext uri="{FF2B5EF4-FFF2-40B4-BE49-F238E27FC236}">
                        <a16:creationId xmlns:a16="http://schemas.microsoft.com/office/drawing/2014/main" id="{0E981C8C-91A4-432A-A974-4C14E2236005}"/>
                      </a:ext>
                    </a:extLst>
                  </p:cNvPr>
                  <p:cNvGrpSpPr/>
                  <p:nvPr/>
                </p:nvGrpSpPr>
                <p:grpSpPr>
                  <a:xfrm>
                    <a:off x="6591846" y="5318777"/>
                    <a:ext cx="1797866" cy="586281"/>
                    <a:chOff x="5842605" y="3234570"/>
                    <a:chExt cx="1853764" cy="645091"/>
                  </a:xfrm>
                </p:grpSpPr>
                <p:sp>
                  <p:nvSpPr>
                    <p:cNvPr id="44" name="Oval 43">
                      <a:extLst>
                        <a:ext uri="{FF2B5EF4-FFF2-40B4-BE49-F238E27FC236}">
                          <a16:creationId xmlns:a16="http://schemas.microsoft.com/office/drawing/2014/main" id="{88DEDBD0-F790-459E-BEF4-AE512A8153B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842605" y="3273698"/>
                      <a:ext cx="914666" cy="356228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R</a:t>
                      </a:r>
                    </a:p>
                  </p:txBody>
                </p:sp>
                <p:sp>
                  <p:nvSpPr>
                    <p:cNvPr id="45" name="Oval 44">
                      <a:extLst>
                        <a:ext uri="{FF2B5EF4-FFF2-40B4-BE49-F238E27FC236}">
                          <a16:creationId xmlns:a16="http://schemas.microsoft.com/office/drawing/2014/main" id="{90293EB8-0756-4495-B31B-4514D7D3318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183544" y="3637078"/>
                      <a:ext cx="831991" cy="242583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G</a:t>
                      </a:r>
                    </a:p>
                  </p:txBody>
                </p:sp>
                <p:sp>
                  <p:nvSpPr>
                    <p:cNvPr id="46" name="Oval 45">
                      <a:extLst>
                        <a:ext uri="{FF2B5EF4-FFF2-40B4-BE49-F238E27FC236}">
                          <a16:creationId xmlns:a16="http://schemas.microsoft.com/office/drawing/2014/main" id="{C1484937-3EC9-4D72-82F8-E53FAD795D2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791976" y="3370696"/>
                      <a:ext cx="882915" cy="242495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CR</a:t>
                      </a:r>
                    </a:p>
                  </p:txBody>
                </p:sp>
                <p:sp>
                  <p:nvSpPr>
                    <p:cNvPr id="47" name="Plus Sign 46">
                      <a:extLst>
                        <a:ext uri="{FF2B5EF4-FFF2-40B4-BE49-F238E27FC236}">
                          <a16:creationId xmlns:a16="http://schemas.microsoft.com/office/drawing/2014/main" id="{D13DBD97-FF68-4175-BAC0-2A6DD4A9DF7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531260" y="3273698"/>
                      <a:ext cx="273535" cy="255267"/>
                    </a:xfrm>
                    <a:prstGeom prst="mathPlus">
                      <a:avLst/>
                    </a:prstGeom>
                    <a:solidFill>
                      <a:schemeClr val="accent5">
                        <a:lumMod val="7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600" dirty="0"/>
                    </a:p>
                  </p:txBody>
                </p:sp>
                <p:sp>
                  <p:nvSpPr>
                    <p:cNvPr id="48" name="Minus Sign 47">
                      <a:extLst>
                        <a:ext uri="{FF2B5EF4-FFF2-40B4-BE49-F238E27FC236}">
                          <a16:creationId xmlns:a16="http://schemas.microsoft.com/office/drawing/2014/main" id="{53E462D3-483B-4B8E-92B5-7CD66881261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399363" y="3234570"/>
                      <a:ext cx="297006" cy="395861"/>
                    </a:xfrm>
                    <a:prstGeom prst="mathMinus">
                      <a:avLst/>
                    </a:prstGeom>
                    <a:solidFill>
                      <a:schemeClr val="accent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600" dirty="0"/>
                    </a:p>
                  </p:txBody>
                </p:sp>
              </p:grpSp>
              <p:sp>
                <p:nvSpPr>
                  <p:cNvPr id="43" name="Plus Sign 42">
                    <a:extLst>
                      <a:ext uri="{FF2B5EF4-FFF2-40B4-BE49-F238E27FC236}">
                        <a16:creationId xmlns:a16="http://schemas.microsoft.com/office/drawing/2014/main" id="{5BD79E54-BD05-46E5-80B4-CF5F877A9EB6}"/>
                      </a:ext>
                    </a:extLst>
                  </p:cNvPr>
                  <p:cNvSpPr/>
                  <p:nvPr/>
                </p:nvSpPr>
                <p:spPr>
                  <a:xfrm>
                    <a:off x="7435706" y="5568591"/>
                    <a:ext cx="265287" cy="231995"/>
                  </a:xfrm>
                  <a:prstGeom prst="mathPlus">
                    <a:avLst/>
                  </a:prstGeom>
                  <a:solidFill>
                    <a:schemeClr val="accent5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27" name="Arrow: Pentagon 26">
                  <a:extLst>
                    <a:ext uri="{FF2B5EF4-FFF2-40B4-BE49-F238E27FC236}">
                      <a16:creationId xmlns:a16="http://schemas.microsoft.com/office/drawing/2014/main" id="{916CAD61-43D6-48F6-88C1-B2600F4E4052}"/>
                    </a:ext>
                  </a:extLst>
                </p:cNvPr>
                <p:cNvSpPr/>
                <p:nvPr/>
              </p:nvSpPr>
              <p:spPr>
                <a:xfrm>
                  <a:off x="5413142" y="4671693"/>
                  <a:ext cx="1512572" cy="310016"/>
                </a:xfrm>
                <a:prstGeom prst="homePlat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4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ene expression</a:t>
                  </a:r>
                </a:p>
              </p:txBody>
            </p:sp>
            <p:sp>
              <p:nvSpPr>
                <p:cNvPr id="28" name="Arrow: Pentagon 27">
                  <a:extLst>
                    <a:ext uri="{FF2B5EF4-FFF2-40B4-BE49-F238E27FC236}">
                      <a16:creationId xmlns:a16="http://schemas.microsoft.com/office/drawing/2014/main" id="{582C2330-BF95-49B5-879A-F512091D181F}"/>
                    </a:ext>
                  </a:extLst>
                </p:cNvPr>
                <p:cNvSpPr/>
                <p:nvPr/>
              </p:nvSpPr>
              <p:spPr>
                <a:xfrm>
                  <a:off x="5020350" y="4746022"/>
                  <a:ext cx="430536" cy="224124"/>
                </a:xfrm>
                <a:prstGeom prst="homePlate">
                  <a:avLst>
                    <a:gd name="adj" fmla="val 83068"/>
                  </a:avLst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29" name="Group 28">
                  <a:extLst>
                    <a:ext uri="{FF2B5EF4-FFF2-40B4-BE49-F238E27FC236}">
                      <a16:creationId xmlns:a16="http://schemas.microsoft.com/office/drawing/2014/main" id="{D6CC1DE6-07DB-4DBF-A821-95D18D6188E9}"/>
                    </a:ext>
                  </a:extLst>
                </p:cNvPr>
                <p:cNvGrpSpPr/>
                <p:nvPr/>
              </p:nvGrpSpPr>
              <p:grpSpPr>
                <a:xfrm>
                  <a:off x="6925714" y="4084468"/>
                  <a:ext cx="1322410" cy="1215444"/>
                  <a:chOff x="7368723" y="4490865"/>
                  <a:chExt cx="1322410" cy="1215444"/>
                </a:xfrm>
              </p:grpSpPr>
              <p:sp>
                <p:nvSpPr>
                  <p:cNvPr id="38" name="Rectangle 37">
                    <a:extLst>
                      <a:ext uri="{FF2B5EF4-FFF2-40B4-BE49-F238E27FC236}">
                        <a16:creationId xmlns:a16="http://schemas.microsoft.com/office/drawing/2014/main" id="{D9BC45F3-0A34-4E43-BE71-0A9C3D2B3CEE}"/>
                      </a:ext>
                    </a:extLst>
                  </p:cNvPr>
                  <p:cNvSpPr/>
                  <p:nvPr/>
                </p:nvSpPr>
                <p:spPr>
                  <a:xfrm>
                    <a:off x="7368723" y="4490865"/>
                    <a:ext cx="732548" cy="121544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2">
                        <a:lumMod val="9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h</a:t>
                    </a:r>
                  </a:p>
                  <a:p>
                    <a:pPr algn="ctr"/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gf-1</a:t>
                    </a:r>
                  </a:p>
                  <a:p>
                    <a:pPr algn="ctr"/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igf-2, </a:t>
                    </a:r>
                  </a:p>
                  <a:p>
                    <a:pPr algn="ctr"/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l-GR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γ </a:t>
                    </a:r>
                    <a:endPara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l-GR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NF-</a:t>
                    </a:r>
                    <a:r>
                      <a:rPr lang="el-GR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α</a:t>
                    </a:r>
                    <a:endParaRPr lang="en-US" sz="1400" i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US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L-1-</a:t>
                    </a:r>
                    <a:r>
                      <a:rPr lang="el-GR" sz="14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β </a:t>
                    </a:r>
                  </a:p>
                </p:txBody>
              </p:sp>
              <p:sp>
                <p:nvSpPr>
                  <p:cNvPr id="39" name="Rectangle 38">
                    <a:extLst>
                      <a:ext uri="{FF2B5EF4-FFF2-40B4-BE49-F238E27FC236}">
                        <a16:creationId xmlns:a16="http://schemas.microsoft.com/office/drawing/2014/main" id="{3C880715-BA91-4D33-BD4C-89B2E9DE8232}"/>
                      </a:ext>
                    </a:extLst>
                  </p:cNvPr>
                  <p:cNvSpPr/>
                  <p:nvPr/>
                </p:nvSpPr>
                <p:spPr>
                  <a:xfrm>
                    <a:off x="8121681" y="4851283"/>
                    <a:ext cx="569452" cy="49744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r>
                      <a:rPr lang="en-US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OD CAT</a:t>
                    </a:r>
                  </a:p>
                </p:txBody>
              </p:sp>
              <p:sp>
                <p:nvSpPr>
                  <p:cNvPr id="40" name="Arrow: Down 39">
                    <a:extLst>
                      <a:ext uri="{FF2B5EF4-FFF2-40B4-BE49-F238E27FC236}">
                        <a16:creationId xmlns:a16="http://schemas.microsoft.com/office/drawing/2014/main" id="{7BC730B4-4AF4-4A9A-87E3-796BECC169C2}"/>
                      </a:ext>
                    </a:extLst>
                  </p:cNvPr>
                  <p:cNvSpPr/>
                  <p:nvPr/>
                </p:nvSpPr>
                <p:spPr>
                  <a:xfrm flipV="1">
                    <a:off x="8024621" y="4497344"/>
                    <a:ext cx="131596" cy="1199471"/>
                  </a:xfrm>
                  <a:prstGeom prst="down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1" name="Arrow: Down 40">
                    <a:extLst>
                      <a:ext uri="{FF2B5EF4-FFF2-40B4-BE49-F238E27FC236}">
                        <a16:creationId xmlns:a16="http://schemas.microsoft.com/office/drawing/2014/main" id="{36D17CDB-887D-415E-AB52-FDDEB8B70D9C}"/>
                      </a:ext>
                    </a:extLst>
                  </p:cNvPr>
                  <p:cNvSpPr/>
                  <p:nvPr/>
                </p:nvSpPr>
                <p:spPr>
                  <a:xfrm>
                    <a:off x="8488398" y="4834633"/>
                    <a:ext cx="112002" cy="497448"/>
                  </a:xfrm>
                  <a:prstGeom prst="down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id="{364884D7-F6B2-4C01-BD7B-7CA0CF9AEEA2}"/>
                    </a:ext>
                  </a:extLst>
                </p:cNvPr>
                <p:cNvGrpSpPr/>
                <p:nvPr/>
              </p:nvGrpSpPr>
              <p:grpSpPr>
                <a:xfrm>
                  <a:off x="5177853" y="3600181"/>
                  <a:ext cx="1422520" cy="1005807"/>
                  <a:chOff x="11171583" y="2563731"/>
                  <a:chExt cx="1422520" cy="1005807"/>
                </a:xfrm>
              </p:grpSpPr>
              <p:pic>
                <p:nvPicPr>
                  <p:cNvPr id="36" name="Picture 35">
                    <a:extLst>
                      <a:ext uri="{FF2B5EF4-FFF2-40B4-BE49-F238E27FC236}">
                        <a16:creationId xmlns:a16="http://schemas.microsoft.com/office/drawing/2014/main" id="{B7E25B4C-DE74-4E36-83D2-DEBCA78D12D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rot="16200000">
                    <a:off x="11490467" y="2506849"/>
                    <a:ext cx="641344" cy="755107"/>
                  </a:xfrm>
                  <a:prstGeom prst="rect">
                    <a:avLst/>
                  </a:prstGeom>
                </p:spPr>
              </p:pic>
              <p:sp>
                <p:nvSpPr>
                  <p:cNvPr id="37" name="Rectangle: Rounded Corners 36">
                    <a:extLst>
                      <a:ext uri="{FF2B5EF4-FFF2-40B4-BE49-F238E27FC236}">
                        <a16:creationId xmlns:a16="http://schemas.microsoft.com/office/drawing/2014/main" id="{64E62CC9-47DD-4871-A048-68945D0F1D44}"/>
                      </a:ext>
                    </a:extLst>
                  </p:cNvPr>
                  <p:cNvSpPr/>
                  <p:nvPr/>
                </p:nvSpPr>
                <p:spPr>
                  <a:xfrm>
                    <a:off x="11171583" y="3185326"/>
                    <a:ext cx="1422520" cy="384212"/>
                  </a:xfrm>
                  <a:prstGeom prst="roundRect">
                    <a:avLst/>
                  </a:prstGeom>
                  <a:solidFill>
                    <a:schemeClr val="bg1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sto-pathological alterations</a:t>
                    </a:r>
                  </a:p>
                </p:txBody>
              </p:sp>
            </p:grpSp>
            <p:sp>
              <p:nvSpPr>
                <p:cNvPr id="31" name="Rectangle: Rounded Corners 30">
                  <a:extLst>
                    <a:ext uri="{FF2B5EF4-FFF2-40B4-BE49-F238E27FC236}">
                      <a16:creationId xmlns:a16="http://schemas.microsoft.com/office/drawing/2014/main" id="{D59FCADC-4694-4907-A268-992DC45DB64B}"/>
                    </a:ext>
                  </a:extLst>
                </p:cNvPr>
                <p:cNvSpPr/>
                <p:nvPr/>
              </p:nvSpPr>
              <p:spPr>
                <a:xfrm>
                  <a:off x="3239101" y="3972019"/>
                  <a:ext cx="1538803" cy="420449"/>
                </a:xfrm>
                <a:prstGeom prst="round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</a:rPr>
                    <a:t>Hematobiochemical parameters</a:t>
                  </a:r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74F9E307-471A-48BA-8B04-E0201C523B61}"/>
                    </a:ext>
                  </a:extLst>
                </p:cNvPr>
                <p:cNvSpPr/>
                <p:nvPr/>
              </p:nvSpPr>
              <p:spPr>
                <a:xfrm>
                  <a:off x="3245805" y="3564786"/>
                  <a:ext cx="567097" cy="3597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u ↓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b </a:t>
                  </a:r>
                  <a:r>
                    <a:rPr lang="en-US" sz="1200" dirty="0">
                      <a:solidFill>
                        <a:schemeClr val="accent3">
                          <a:lumMod val="50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↑</a:t>
                  </a:r>
                  <a:endPara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3" name="Group 32">
                  <a:extLst>
                    <a:ext uri="{FF2B5EF4-FFF2-40B4-BE49-F238E27FC236}">
                      <a16:creationId xmlns:a16="http://schemas.microsoft.com/office/drawing/2014/main" id="{269688B8-9109-4503-A4AD-F87F3DE37C99}"/>
                    </a:ext>
                  </a:extLst>
                </p:cNvPr>
                <p:cNvGrpSpPr/>
                <p:nvPr/>
              </p:nvGrpSpPr>
              <p:grpSpPr>
                <a:xfrm>
                  <a:off x="3976512" y="3572019"/>
                  <a:ext cx="675826" cy="359772"/>
                  <a:chOff x="4135535" y="2609926"/>
                  <a:chExt cx="675826" cy="359772"/>
                </a:xfrm>
              </p:grpSpPr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7E0B8C7F-00D7-4A8A-95F4-858701226653}"/>
                      </a:ext>
                    </a:extLst>
                  </p:cNvPr>
                  <p:cNvSpPr/>
                  <p:nvPr/>
                </p:nvSpPr>
                <p:spPr>
                  <a:xfrm>
                    <a:off x="4135535" y="2609926"/>
                    <a:ext cx="521027" cy="35977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CA</a:t>
                    </a:r>
                  </a:p>
                  <a:p>
                    <a:pPr algn="ctr"/>
                    <a:r>
                      <a:rPr 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NA</a:t>
                    </a:r>
                  </a:p>
                </p:txBody>
              </p:sp>
              <p:sp>
                <p:nvSpPr>
                  <p:cNvPr id="35" name="Arrow: Down 34">
                    <a:extLst>
                      <a:ext uri="{FF2B5EF4-FFF2-40B4-BE49-F238E27FC236}">
                        <a16:creationId xmlns:a16="http://schemas.microsoft.com/office/drawing/2014/main" id="{A33BC77A-7B4D-456D-93FA-73CD34ADC30A}"/>
                      </a:ext>
                    </a:extLst>
                  </p:cNvPr>
                  <p:cNvSpPr/>
                  <p:nvPr/>
                </p:nvSpPr>
                <p:spPr>
                  <a:xfrm>
                    <a:off x="4702676" y="2609926"/>
                    <a:ext cx="108685" cy="359772"/>
                  </a:xfrm>
                  <a:prstGeom prst="downArrow">
                    <a:avLst/>
                  </a:prstGeom>
                  <a:solidFill>
                    <a:schemeClr val="accent2">
                      <a:lumMod val="75000"/>
                    </a:schemeClr>
                  </a:solidFill>
                  <a:scene3d>
                    <a:camera prst="orthographicFront"/>
                    <a:lightRig rig="threePt" dir="t"/>
                  </a:scene3d>
                  <a:sp3d>
                    <a:bevelT prst="angle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</p:grpSp>
        <p:sp>
          <p:nvSpPr>
            <p:cNvPr id="4" name="Arrow: Pentagon 3">
              <a:extLst>
                <a:ext uri="{FF2B5EF4-FFF2-40B4-BE49-F238E27FC236}">
                  <a16:creationId xmlns:a16="http://schemas.microsoft.com/office/drawing/2014/main" id="{94F4610C-3ECC-4CD9-9796-0921FFD25A84}"/>
                </a:ext>
              </a:extLst>
            </p:cNvPr>
            <p:cNvSpPr/>
            <p:nvPr/>
          </p:nvSpPr>
          <p:spPr>
            <a:xfrm>
              <a:off x="6555046" y="1941746"/>
              <a:ext cx="1417297" cy="379997"/>
            </a:xfrm>
            <a:prstGeom prst="homePlate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14634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9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ika Anjum</dc:creator>
  <cp:lastModifiedBy>HP</cp:lastModifiedBy>
  <cp:revision>2</cp:revision>
  <dcterms:created xsi:type="dcterms:W3CDTF">2025-11-14T09:14:14Z</dcterms:created>
  <dcterms:modified xsi:type="dcterms:W3CDTF">2025-11-16T09:25:51Z</dcterms:modified>
</cp:coreProperties>
</file>